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6" r:id="rId2"/>
    <p:sldId id="264" r:id="rId3"/>
    <p:sldId id="267" r:id="rId4"/>
    <p:sldId id="268" r:id="rId5"/>
    <p:sldId id="265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F7038B4-4E4C-4B4B-BD81-4D765AB1CB7A}" v="22" dt="2022-04-22T18:49:45.9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57" d="100"/>
          <a:sy n="57" d="100"/>
        </p:scale>
        <p:origin x="2467" y="67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k Ihrie" userId="b056c03dfdfb59ce" providerId="LiveId" clId="{8E6DE7BC-9F40-4BD2-B7BB-1ABA931843CA}"/>
    <pc:docChg chg="undo custSel addSld delSld modSld">
      <pc:chgData name="Mark Ihrie" userId="b056c03dfdfb59ce" providerId="LiveId" clId="{8E6DE7BC-9F40-4BD2-B7BB-1ABA931843CA}" dt="2021-12-02T19:22:19.103" v="75" actId="20577"/>
      <pc:docMkLst>
        <pc:docMk/>
      </pc:docMkLst>
      <pc:sldChg chg="addSp delSp modSp mod">
        <pc:chgData name="Mark Ihrie" userId="b056c03dfdfb59ce" providerId="LiveId" clId="{8E6DE7BC-9F40-4BD2-B7BB-1ABA931843CA}" dt="2021-12-02T19:22:15.081" v="74" actId="20577"/>
        <pc:sldMkLst>
          <pc:docMk/>
          <pc:sldMk cId="3256113167" sldId="264"/>
        </pc:sldMkLst>
        <pc:spChg chg="del mod">
          <ac:chgData name="Mark Ihrie" userId="b056c03dfdfb59ce" providerId="LiveId" clId="{8E6DE7BC-9F40-4BD2-B7BB-1ABA931843CA}" dt="2021-12-02T17:29:38.547" v="7" actId="478"/>
          <ac:spMkLst>
            <pc:docMk/>
            <pc:sldMk cId="3256113167" sldId="264"/>
            <ac:spMk id="4" creationId="{1F841981-2FB0-4EA1-9A33-17822BD5802C}"/>
          </ac:spMkLst>
        </pc:spChg>
        <pc:spChg chg="mod">
          <ac:chgData name="Mark Ihrie" userId="b056c03dfdfb59ce" providerId="LiveId" clId="{8E6DE7BC-9F40-4BD2-B7BB-1ABA931843CA}" dt="2021-12-02T17:31:26.899" v="22" actId="1076"/>
          <ac:spMkLst>
            <pc:docMk/>
            <pc:sldMk cId="3256113167" sldId="264"/>
            <ac:spMk id="7" creationId="{ECF1F17A-7FCD-4A64-BE69-746292696253}"/>
          </ac:spMkLst>
        </pc:spChg>
        <pc:spChg chg="mod">
          <ac:chgData name="Mark Ihrie" userId="b056c03dfdfb59ce" providerId="LiveId" clId="{8E6DE7BC-9F40-4BD2-B7BB-1ABA931843CA}" dt="2021-12-02T17:31:26.899" v="22" actId="1076"/>
          <ac:spMkLst>
            <pc:docMk/>
            <pc:sldMk cId="3256113167" sldId="264"/>
            <ac:spMk id="8" creationId="{6E2A6C2B-5466-4154-AAC3-FED68517CD2E}"/>
          </ac:spMkLst>
        </pc:spChg>
        <pc:spChg chg="add mod">
          <ac:chgData name="Mark Ihrie" userId="b056c03dfdfb59ce" providerId="LiveId" clId="{8E6DE7BC-9F40-4BD2-B7BB-1ABA931843CA}" dt="2021-12-02T19:22:15.081" v="74" actId="20577"/>
          <ac:spMkLst>
            <pc:docMk/>
            <pc:sldMk cId="3256113167" sldId="264"/>
            <ac:spMk id="10" creationId="{B09AF426-25D5-4F1B-9DA1-3CDE1A6E32DB}"/>
          </ac:spMkLst>
        </pc:spChg>
        <pc:graphicFrameChg chg="mod">
          <ac:chgData name="Mark Ihrie" userId="b056c03dfdfb59ce" providerId="LiveId" clId="{8E6DE7BC-9F40-4BD2-B7BB-1ABA931843CA}" dt="2021-12-02T17:31:26.899" v="22" actId="1076"/>
          <ac:graphicFrameMkLst>
            <pc:docMk/>
            <pc:sldMk cId="3256113167" sldId="264"/>
            <ac:graphicFrameMk id="5" creationId="{89E6C66C-68AD-4414-90F3-DB4FC38BAFDB}"/>
          </ac:graphicFrameMkLst>
        </pc:graphicFrameChg>
        <pc:graphicFrameChg chg="mod">
          <ac:chgData name="Mark Ihrie" userId="b056c03dfdfb59ce" providerId="LiveId" clId="{8E6DE7BC-9F40-4BD2-B7BB-1ABA931843CA}" dt="2021-12-02T17:31:26.899" v="22" actId="1076"/>
          <ac:graphicFrameMkLst>
            <pc:docMk/>
            <pc:sldMk cId="3256113167" sldId="264"/>
            <ac:graphicFrameMk id="6" creationId="{3FA321A7-8610-4372-A1E6-6C591B62663F}"/>
          </ac:graphicFrameMkLst>
        </pc:graphicFrameChg>
        <pc:picChg chg="mod">
          <ac:chgData name="Mark Ihrie" userId="b056c03dfdfb59ce" providerId="LiveId" clId="{8E6DE7BC-9F40-4BD2-B7BB-1ABA931843CA}" dt="2021-12-02T17:31:26.899" v="22" actId="1076"/>
          <ac:picMkLst>
            <pc:docMk/>
            <pc:sldMk cId="3256113167" sldId="264"/>
            <ac:picMk id="9" creationId="{C7F19CAC-BF79-40FD-8600-64E017185056}"/>
          </ac:picMkLst>
        </pc:picChg>
      </pc:sldChg>
      <pc:sldChg chg="addSp delSp modSp mod">
        <pc:chgData name="Mark Ihrie" userId="b056c03dfdfb59ce" providerId="LiveId" clId="{8E6DE7BC-9F40-4BD2-B7BB-1ABA931843CA}" dt="2021-12-02T19:22:19.103" v="75" actId="20577"/>
        <pc:sldMkLst>
          <pc:docMk/>
          <pc:sldMk cId="2013115125" sldId="265"/>
        </pc:sldMkLst>
        <pc:spChg chg="del">
          <ac:chgData name="Mark Ihrie" userId="b056c03dfdfb59ce" providerId="LiveId" clId="{8E6DE7BC-9F40-4BD2-B7BB-1ABA931843CA}" dt="2021-12-02T17:32:26.312" v="34" actId="478"/>
          <ac:spMkLst>
            <pc:docMk/>
            <pc:sldMk cId="2013115125" sldId="265"/>
            <ac:spMk id="3" creationId="{EACE10DE-4B03-4770-95B9-3F0973DC5770}"/>
          </ac:spMkLst>
        </pc:spChg>
        <pc:spChg chg="mod">
          <ac:chgData name="Mark Ihrie" userId="b056c03dfdfb59ce" providerId="LiveId" clId="{8E6DE7BC-9F40-4BD2-B7BB-1ABA931843CA}" dt="2021-12-02T17:32:37.723" v="35" actId="1076"/>
          <ac:spMkLst>
            <pc:docMk/>
            <pc:sldMk cId="2013115125" sldId="265"/>
            <ac:spMk id="10" creationId="{16D4D6D8-CD25-4179-B2E3-2769329F8E3F}"/>
          </ac:spMkLst>
        </pc:spChg>
        <pc:spChg chg="mod">
          <ac:chgData name="Mark Ihrie" userId="b056c03dfdfb59ce" providerId="LiveId" clId="{8E6DE7BC-9F40-4BD2-B7BB-1ABA931843CA}" dt="2021-12-02T17:32:37.723" v="35" actId="1076"/>
          <ac:spMkLst>
            <pc:docMk/>
            <pc:sldMk cId="2013115125" sldId="265"/>
            <ac:spMk id="11" creationId="{9B4DDDBB-3B2A-43E3-BD14-E2EB65267593}"/>
          </ac:spMkLst>
        </pc:spChg>
        <pc:spChg chg="mod">
          <ac:chgData name="Mark Ihrie" userId="b056c03dfdfb59ce" providerId="LiveId" clId="{8E6DE7BC-9F40-4BD2-B7BB-1ABA931843CA}" dt="2021-12-02T17:58:37.657" v="69" actId="1076"/>
          <ac:spMkLst>
            <pc:docMk/>
            <pc:sldMk cId="2013115125" sldId="265"/>
            <ac:spMk id="12" creationId="{68FBDC9C-E78A-416F-BA70-8D2B159A8203}"/>
          </ac:spMkLst>
        </pc:spChg>
        <pc:spChg chg="add mod">
          <ac:chgData name="Mark Ihrie" userId="b056c03dfdfb59ce" providerId="LiveId" clId="{8E6DE7BC-9F40-4BD2-B7BB-1ABA931843CA}" dt="2021-12-02T19:22:19.103" v="75" actId="20577"/>
          <ac:spMkLst>
            <pc:docMk/>
            <pc:sldMk cId="2013115125" sldId="265"/>
            <ac:spMk id="13" creationId="{44D3565F-328F-4149-B5E3-B55FACFD657C}"/>
          </ac:spMkLst>
        </pc:spChg>
        <pc:graphicFrameChg chg="del mod">
          <ac:chgData name="Mark Ihrie" userId="b056c03dfdfb59ce" providerId="LiveId" clId="{8E6DE7BC-9F40-4BD2-B7BB-1ABA931843CA}" dt="2021-12-02T17:53:27.718" v="39" actId="478"/>
          <ac:graphicFrameMkLst>
            <pc:docMk/>
            <pc:sldMk cId="2013115125" sldId="265"/>
            <ac:graphicFrameMk id="7" creationId="{301D17D8-982E-4540-8292-B125EE1FCCD7}"/>
          </ac:graphicFrameMkLst>
        </pc:graphicFrameChg>
        <pc:graphicFrameChg chg="add del mod">
          <ac:chgData name="Mark Ihrie" userId="b056c03dfdfb59ce" providerId="LiveId" clId="{8E6DE7BC-9F40-4BD2-B7BB-1ABA931843CA}" dt="2021-12-02T17:56:59.024" v="48" actId="478"/>
          <ac:graphicFrameMkLst>
            <pc:docMk/>
            <pc:sldMk cId="2013115125" sldId="265"/>
            <ac:graphicFrameMk id="8" creationId="{306257B9-CBF4-442A-AD1E-5676E590CEDC}"/>
          </ac:graphicFrameMkLst>
        </pc:graphicFrameChg>
        <pc:graphicFrameChg chg="del mod">
          <ac:chgData name="Mark Ihrie" userId="b056c03dfdfb59ce" providerId="LiveId" clId="{8E6DE7BC-9F40-4BD2-B7BB-1ABA931843CA}" dt="2021-12-02T17:57:53.909" v="55" actId="478"/>
          <ac:graphicFrameMkLst>
            <pc:docMk/>
            <pc:sldMk cId="2013115125" sldId="265"/>
            <ac:graphicFrameMk id="9" creationId="{D0520710-98C4-41B4-9EDE-CF12931BC171}"/>
          </ac:graphicFrameMkLst>
        </pc:graphicFrameChg>
        <pc:graphicFrameChg chg="add mod">
          <ac:chgData name="Mark Ihrie" userId="b056c03dfdfb59ce" providerId="LiveId" clId="{8E6DE7BC-9F40-4BD2-B7BB-1ABA931843CA}" dt="2021-12-02T17:53:51.397" v="43" actId="1076"/>
          <ac:graphicFrameMkLst>
            <pc:docMk/>
            <pc:sldMk cId="2013115125" sldId="265"/>
            <ac:graphicFrameMk id="14" creationId="{1DB29E8D-D3A9-429A-87E9-3ED7892F3580}"/>
          </ac:graphicFrameMkLst>
        </pc:graphicFrameChg>
        <pc:graphicFrameChg chg="add mod">
          <ac:chgData name="Mark Ihrie" userId="b056c03dfdfb59ce" providerId="LiveId" clId="{8E6DE7BC-9F40-4BD2-B7BB-1ABA931843CA}" dt="2021-12-02T17:58:18.435" v="63" actId="1076"/>
          <ac:graphicFrameMkLst>
            <pc:docMk/>
            <pc:sldMk cId="2013115125" sldId="265"/>
            <ac:graphicFrameMk id="15" creationId="{24CE5573-1A71-44B6-82F0-51EC338599D4}"/>
          </ac:graphicFrameMkLst>
        </pc:graphicFrameChg>
        <pc:graphicFrameChg chg="add mod">
          <ac:chgData name="Mark Ihrie" userId="b056c03dfdfb59ce" providerId="LiveId" clId="{8E6DE7BC-9F40-4BD2-B7BB-1ABA931843CA}" dt="2021-12-02T17:58:27.232" v="66" actId="1076"/>
          <ac:graphicFrameMkLst>
            <pc:docMk/>
            <pc:sldMk cId="2013115125" sldId="265"/>
            <ac:graphicFrameMk id="16" creationId="{1EA88D24-D65A-44D2-8A26-99D28F1C4B8A}"/>
          </ac:graphicFrameMkLst>
        </pc:graphicFrameChg>
      </pc:sldChg>
      <pc:sldChg chg="addSp delSp modSp mod">
        <pc:chgData name="Mark Ihrie" userId="b056c03dfdfb59ce" providerId="LiveId" clId="{8E6DE7BC-9F40-4BD2-B7BB-1ABA931843CA}" dt="2021-12-02T17:31:13.547" v="21" actId="1076"/>
        <pc:sldMkLst>
          <pc:docMk/>
          <pc:sldMk cId="1586498832" sldId="266"/>
        </pc:sldMkLst>
        <pc:spChg chg="del">
          <ac:chgData name="Mark Ihrie" userId="b056c03dfdfb59ce" providerId="LiveId" clId="{8E6DE7BC-9F40-4BD2-B7BB-1ABA931843CA}" dt="2021-12-02T17:29:16.330" v="4" actId="478"/>
          <ac:spMkLst>
            <pc:docMk/>
            <pc:sldMk cId="1586498832" sldId="266"/>
            <ac:spMk id="4" creationId="{70736D91-672B-46FD-BD5F-8C1BA2F69A94}"/>
          </ac:spMkLst>
        </pc:spChg>
        <pc:spChg chg="add mod">
          <ac:chgData name="Mark Ihrie" userId="b056c03dfdfb59ce" providerId="LiveId" clId="{8E6DE7BC-9F40-4BD2-B7BB-1ABA931843CA}" dt="2021-12-02T17:31:13.547" v="21" actId="1076"/>
          <ac:spMkLst>
            <pc:docMk/>
            <pc:sldMk cId="1586498832" sldId="266"/>
            <ac:spMk id="22" creationId="{2E2A0478-00F8-45BC-8753-E336A73317F0}"/>
          </ac:spMkLst>
        </pc:spChg>
      </pc:sldChg>
      <pc:sldChg chg="addSp modSp add del">
        <pc:chgData name="Mark Ihrie" userId="b056c03dfdfb59ce" providerId="LiveId" clId="{8E6DE7BC-9F40-4BD2-B7BB-1ABA931843CA}" dt="2021-12-02T17:58:47.611" v="72" actId="47"/>
        <pc:sldMkLst>
          <pc:docMk/>
          <pc:sldMk cId="270521238" sldId="267"/>
        </pc:sldMkLst>
        <pc:graphicFrameChg chg="add mod">
          <ac:chgData name="Mark Ihrie" userId="b056c03dfdfb59ce" providerId="LiveId" clId="{8E6DE7BC-9F40-4BD2-B7BB-1ABA931843CA}" dt="2021-12-02T17:53:23.299" v="38"/>
          <ac:graphicFrameMkLst>
            <pc:docMk/>
            <pc:sldMk cId="270521238" sldId="267"/>
            <ac:graphicFrameMk id="2" creationId="{58BF585A-4E19-40AF-9787-A5C226B2FD32}"/>
          </ac:graphicFrameMkLst>
        </pc:graphicFrameChg>
      </pc:sldChg>
      <pc:sldChg chg="addSp modSp add del">
        <pc:chgData name="Mark Ihrie" userId="b056c03dfdfb59ce" providerId="LiveId" clId="{8E6DE7BC-9F40-4BD2-B7BB-1ABA931843CA}" dt="2021-12-02T17:58:46.523" v="71" actId="47"/>
        <pc:sldMkLst>
          <pc:docMk/>
          <pc:sldMk cId="872854915" sldId="268"/>
        </pc:sldMkLst>
        <pc:graphicFrameChg chg="add mod">
          <ac:chgData name="Mark Ihrie" userId="b056c03dfdfb59ce" providerId="LiveId" clId="{8E6DE7BC-9F40-4BD2-B7BB-1ABA931843CA}" dt="2021-12-02T17:56:51.925" v="47"/>
          <ac:graphicFrameMkLst>
            <pc:docMk/>
            <pc:sldMk cId="872854915" sldId="268"/>
            <ac:graphicFrameMk id="2" creationId="{AE68F26C-808E-4B0D-84F8-9B35EE18EF6B}"/>
          </ac:graphicFrameMkLst>
        </pc:graphicFrameChg>
      </pc:sldChg>
      <pc:sldChg chg="addSp modSp add del">
        <pc:chgData name="Mark Ihrie" userId="b056c03dfdfb59ce" providerId="LiveId" clId="{8E6DE7BC-9F40-4BD2-B7BB-1ABA931843CA}" dt="2021-12-02T17:58:45.055" v="70" actId="47"/>
        <pc:sldMkLst>
          <pc:docMk/>
          <pc:sldMk cId="698009674" sldId="269"/>
        </pc:sldMkLst>
        <pc:graphicFrameChg chg="add mod">
          <ac:chgData name="Mark Ihrie" userId="b056c03dfdfb59ce" providerId="LiveId" clId="{8E6DE7BC-9F40-4BD2-B7BB-1ABA931843CA}" dt="2021-12-02T17:57:39.240" v="54"/>
          <ac:graphicFrameMkLst>
            <pc:docMk/>
            <pc:sldMk cId="698009674" sldId="269"/>
            <ac:graphicFrameMk id="2" creationId="{08976A0F-DBE7-4EFE-86F9-244386D8799B}"/>
          </ac:graphicFrameMkLst>
        </pc:graphicFrameChg>
      </pc:sldChg>
    </pc:docChg>
  </pc:docChgLst>
  <pc:docChgLst>
    <pc:chgData name="Mark Ihrie" userId="b056c03dfdfb59ce" providerId="LiveId" clId="{FF7038B4-4E4C-4B4B-BD81-4D765AB1CB7A}"/>
    <pc:docChg chg="undo custSel addSld delSld modSld sldOrd">
      <pc:chgData name="Mark Ihrie" userId="b056c03dfdfb59ce" providerId="LiveId" clId="{FF7038B4-4E4C-4B4B-BD81-4D765AB1CB7A}" dt="2022-04-22T18:49:46.066" v="453" actId="47"/>
      <pc:docMkLst>
        <pc:docMk/>
      </pc:docMkLst>
      <pc:sldChg chg="modSp mod">
        <pc:chgData name="Mark Ihrie" userId="b056c03dfdfb59ce" providerId="LiveId" clId="{FF7038B4-4E4C-4B4B-BD81-4D765AB1CB7A}" dt="2022-02-14T17:53:23.093" v="159" actId="20577"/>
        <pc:sldMkLst>
          <pc:docMk/>
          <pc:sldMk cId="3256113167" sldId="264"/>
        </pc:sldMkLst>
        <pc:spChg chg="mod">
          <ac:chgData name="Mark Ihrie" userId="b056c03dfdfb59ce" providerId="LiveId" clId="{FF7038B4-4E4C-4B4B-BD81-4D765AB1CB7A}" dt="2022-02-14T17:53:23.093" v="159" actId="20577"/>
          <ac:spMkLst>
            <pc:docMk/>
            <pc:sldMk cId="3256113167" sldId="264"/>
            <ac:spMk id="10" creationId="{B09AF426-25D5-4F1B-9DA1-3CDE1A6E32DB}"/>
          </ac:spMkLst>
        </pc:spChg>
      </pc:sldChg>
      <pc:sldChg chg="modSp mod">
        <pc:chgData name="Mark Ihrie" userId="b056c03dfdfb59ce" providerId="LiveId" clId="{FF7038B4-4E4C-4B4B-BD81-4D765AB1CB7A}" dt="2022-02-14T18:01:04.482" v="308" actId="20577"/>
        <pc:sldMkLst>
          <pc:docMk/>
          <pc:sldMk cId="2013115125" sldId="265"/>
        </pc:sldMkLst>
        <pc:spChg chg="mod">
          <ac:chgData name="Mark Ihrie" userId="b056c03dfdfb59ce" providerId="LiveId" clId="{FF7038B4-4E4C-4B4B-BD81-4D765AB1CB7A}" dt="2022-02-14T18:01:04.482" v="308" actId="20577"/>
          <ac:spMkLst>
            <pc:docMk/>
            <pc:sldMk cId="2013115125" sldId="265"/>
            <ac:spMk id="13" creationId="{44D3565F-328F-4149-B5E3-B55FACFD657C}"/>
          </ac:spMkLst>
        </pc:spChg>
      </pc:sldChg>
      <pc:sldChg chg="addSp modSp new mod ord">
        <pc:chgData name="Mark Ihrie" userId="b056c03dfdfb59ce" providerId="LiveId" clId="{FF7038B4-4E4C-4B4B-BD81-4D765AB1CB7A}" dt="2022-02-14T17:53:26.663" v="161" actId="20577"/>
        <pc:sldMkLst>
          <pc:docMk/>
          <pc:sldMk cId="1361493262" sldId="267"/>
        </pc:sldMkLst>
        <pc:spChg chg="add mod">
          <ac:chgData name="Mark Ihrie" userId="b056c03dfdfb59ce" providerId="LiveId" clId="{FF7038B4-4E4C-4B4B-BD81-4D765AB1CB7A}" dt="2022-02-14T17:53:26.663" v="161" actId="20577"/>
          <ac:spMkLst>
            <pc:docMk/>
            <pc:sldMk cId="1361493262" sldId="267"/>
            <ac:spMk id="2" creationId="{5F36E899-8FEA-4D02-AB5D-800DADADFD8C}"/>
          </ac:spMkLst>
        </pc:spChg>
        <pc:graphicFrameChg chg="add mod">
          <ac:chgData name="Mark Ihrie" userId="b056c03dfdfb59ce" providerId="LiveId" clId="{FF7038B4-4E4C-4B4B-BD81-4D765AB1CB7A}" dt="2022-02-14T17:45:51.108" v="5" actId="1076"/>
          <ac:graphicFrameMkLst>
            <pc:docMk/>
            <pc:sldMk cId="1361493262" sldId="267"/>
            <ac:graphicFrameMk id="3" creationId="{C72D3346-31DD-462B-9187-CC81B1FCD7DF}"/>
          </ac:graphicFrameMkLst>
        </pc:graphicFrameChg>
      </pc:sldChg>
      <pc:sldChg chg="addSp modSp new mod">
        <pc:chgData name="Mark Ihrie" userId="b056c03dfdfb59ce" providerId="LiveId" clId="{FF7038B4-4E4C-4B4B-BD81-4D765AB1CB7A}" dt="2022-04-22T18:49:39.045" v="452" actId="1076"/>
        <pc:sldMkLst>
          <pc:docMk/>
          <pc:sldMk cId="2496432916" sldId="268"/>
        </pc:sldMkLst>
        <pc:spChg chg="add mod">
          <ac:chgData name="Mark Ihrie" userId="b056c03dfdfb59ce" providerId="LiveId" clId="{FF7038B4-4E4C-4B4B-BD81-4D765AB1CB7A}" dt="2022-04-22T18:48:40.859" v="442" actId="20577"/>
          <ac:spMkLst>
            <pc:docMk/>
            <pc:sldMk cId="2496432916" sldId="268"/>
            <ac:spMk id="2" creationId="{FCCDAA3D-2257-4795-93DB-A1B906D5ECAD}"/>
          </ac:spMkLst>
        </pc:spChg>
        <pc:spChg chg="add mod">
          <ac:chgData name="Mark Ihrie" userId="b056c03dfdfb59ce" providerId="LiveId" clId="{FF7038B4-4E4C-4B4B-BD81-4D765AB1CB7A}" dt="2022-04-22T18:41:12.770" v="405" actId="1076"/>
          <ac:spMkLst>
            <pc:docMk/>
            <pc:sldMk cId="2496432916" sldId="268"/>
            <ac:spMk id="5" creationId="{63F29EF2-1711-41A0-ADAA-E9D146E60190}"/>
          </ac:spMkLst>
        </pc:spChg>
        <pc:spChg chg="add mod">
          <ac:chgData name="Mark Ihrie" userId="b056c03dfdfb59ce" providerId="LiveId" clId="{FF7038B4-4E4C-4B4B-BD81-4D765AB1CB7A}" dt="2022-04-22T18:41:06.438" v="402" actId="1076"/>
          <ac:spMkLst>
            <pc:docMk/>
            <pc:sldMk cId="2496432916" sldId="268"/>
            <ac:spMk id="6" creationId="{14B696B7-BDB2-4134-8352-F774CD1548A2}"/>
          </ac:spMkLst>
        </pc:spChg>
        <pc:spChg chg="add mod">
          <ac:chgData name="Mark Ihrie" userId="b056c03dfdfb59ce" providerId="LiveId" clId="{FF7038B4-4E4C-4B4B-BD81-4D765AB1CB7A}" dt="2022-04-22T18:41:27.416" v="409" actId="20577"/>
          <ac:spMkLst>
            <pc:docMk/>
            <pc:sldMk cId="2496432916" sldId="268"/>
            <ac:spMk id="8" creationId="{6841DE14-148A-4195-9A6D-73E7870A1BBA}"/>
          </ac:spMkLst>
        </pc:spChg>
        <pc:spChg chg="add mod">
          <ac:chgData name="Mark Ihrie" userId="b056c03dfdfb59ce" providerId="LiveId" clId="{FF7038B4-4E4C-4B4B-BD81-4D765AB1CB7A}" dt="2022-04-22T18:49:39.045" v="452" actId="1076"/>
          <ac:spMkLst>
            <pc:docMk/>
            <pc:sldMk cId="2496432916" sldId="268"/>
            <ac:spMk id="10" creationId="{9E09D1D1-ECE8-4FF9-86B4-D7634DF9050D}"/>
          </ac:spMkLst>
        </pc:spChg>
        <pc:graphicFrameChg chg="add mod">
          <ac:chgData name="Mark Ihrie" userId="b056c03dfdfb59ce" providerId="LiveId" clId="{FF7038B4-4E4C-4B4B-BD81-4D765AB1CB7A}" dt="2022-04-22T18:41:03.016" v="401" actId="1076"/>
          <ac:graphicFrameMkLst>
            <pc:docMk/>
            <pc:sldMk cId="2496432916" sldId="268"/>
            <ac:graphicFrameMk id="3" creationId="{A52B1F09-9508-4B85-A5FF-4BFEC11A6FF3}"/>
          </ac:graphicFrameMkLst>
        </pc:graphicFrameChg>
        <pc:graphicFrameChg chg="add mod">
          <ac:chgData name="Mark Ihrie" userId="b056c03dfdfb59ce" providerId="LiveId" clId="{FF7038B4-4E4C-4B4B-BD81-4D765AB1CB7A}" dt="2022-04-22T18:40:47.216" v="394" actId="1076"/>
          <ac:graphicFrameMkLst>
            <pc:docMk/>
            <pc:sldMk cId="2496432916" sldId="268"/>
            <ac:graphicFrameMk id="4" creationId="{FE74C0B4-A6CF-468B-BB2E-9420847BAE29}"/>
          </ac:graphicFrameMkLst>
        </pc:graphicFrameChg>
        <pc:graphicFrameChg chg="add mod">
          <ac:chgData name="Mark Ihrie" userId="b056c03dfdfb59ce" providerId="LiveId" clId="{FF7038B4-4E4C-4B4B-BD81-4D765AB1CB7A}" dt="2022-04-22T18:41:08.792" v="404" actId="1076"/>
          <ac:graphicFrameMkLst>
            <pc:docMk/>
            <pc:sldMk cId="2496432916" sldId="268"/>
            <ac:graphicFrameMk id="7" creationId="{5419868E-19D5-4971-9EA0-CF4689223B69}"/>
          </ac:graphicFrameMkLst>
        </pc:graphicFrameChg>
        <pc:graphicFrameChg chg="add mod">
          <ac:chgData name="Mark Ihrie" userId="b056c03dfdfb59ce" providerId="LiveId" clId="{FF7038B4-4E4C-4B4B-BD81-4D765AB1CB7A}" dt="2022-04-22T18:49:21.158" v="447" actId="1076"/>
          <ac:graphicFrameMkLst>
            <pc:docMk/>
            <pc:sldMk cId="2496432916" sldId="268"/>
            <ac:graphicFrameMk id="9" creationId="{F5DA7371-9340-4466-A0DB-F0A7E30F69A8}"/>
          </ac:graphicFrameMkLst>
        </pc:graphicFrameChg>
      </pc:sldChg>
      <pc:sldChg chg="addSp modSp add del">
        <pc:chgData name="Mark Ihrie" userId="b056c03dfdfb59ce" providerId="LiveId" clId="{FF7038B4-4E4C-4B4B-BD81-4D765AB1CB7A}" dt="2022-02-14T17:47:14.066" v="153" actId="47"/>
        <pc:sldMkLst>
          <pc:docMk/>
          <pc:sldMk cId="4185013622" sldId="268"/>
        </pc:sldMkLst>
        <pc:graphicFrameChg chg="add mod">
          <ac:chgData name="Mark Ihrie" userId="b056c03dfdfb59ce" providerId="LiveId" clId="{FF7038B4-4E4C-4B4B-BD81-4D765AB1CB7A}" dt="2022-02-14T17:45:37.567" v="3"/>
          <ac:graphicFrameMkLst>
            <pc:docMk/>
            <pc:sldMk cId="4185013622" sldId="268"/>
            <ac:graphicFrameMk id="2" creationId="{D28A741E-0A22-4455-B282-D3FBAABAFB8F}"/>
          </ac:graphicFrameMkLst>
        </pc:graphicFrameChg>
      </pc:sldChg>
      <pc:sldChg chg="addSp modSp add del">
        <pc:chgData name="Mark Ihrie" userId="b056c03dfdfb59ce" providerId="LiveId" clId="{FF7038B4-4E4C-4B4B-BD81-4D765AB1CB7A}" dt="2022-04-22T18:49:46.066" v="453" actId="47"/>
        <pc:sldMkLst>
          <pc:docMk/>
          <pc:sldMk cId="2481897853" sldId="269"/>
        </pc:sldMkLst>
        <pc:graphicFrameChg chg="add mod">
          <ac:chgData name="Mark Ihrie" userId="b056c03dfdfb59ce" providerId="LiveId" clId="{FF7038B4-4E4C-4B4B-BD81-4D765AB1CB7A}" dt="2022-04-22T18:48:58.063" v="444"/>
          <ac:graphicFrameMkLst>
            <pc:docMk/>
            <pc:sldMk cId="2481897853" sldId="269"/>
            <ac:graphicFrameMk id="2" creationId="{4746AF12-F1CF-49E7-83FC-32730806B195}"/>
          </ac:graphicFrameMkLst>
        </pc:graphicFrameChg>
      </pc:sldChg>
      <pc:sldChg chg="addSp modSp add del">
        <pc:chgData name="Mark Ihrie" userId="b056c03dfdfb59ce" providerId="LiveId" clId="{FF7038B4-4E4C-4B4B-BD81-4D765AB1CB7A}" dt="2022-02-14T17:55:04.400" v="174" actId="47"/>
        <pc:sldMkLst>
          <pc:docMk/>
          <pc:sldMk cId="3332674707" sldId="269"/>
        </pc:sldMkLst>
        <pc:graphicFrameChg chg="add mod">
          <ac:chgData name="Mark Ihrie" userId="b056c03dfdfb59ce" providerId="LiveId" clId="{FF7038B4-4E4C-4B4B-BD81-4D765AB1CB7A}" dt="2022-02-14T17:54:39.793" v="167"/>
          <ac:graphicFrameMkLst>
            <pc:docMk/>
            <pc:sldMk cId="3332674707" sldId="269"/>
            <ac:graphicFrameMk id="2" creationId="{93593860-596A-49C3-9AF4-408E065C77D9}"/>
          </ac:graphicFrameMkLst>
        </pc:graphicFrameChg>
      </pc:sldChg>
      <pc:sldChg chg="addSp modSp add del">
        <pc:chgData name="Mark Ihrie" userId="b056c03dfdfb59ce" providerId="LiveId" clId="{FF7038B4-4E4C-4B4B-BD81-4D765AB1CB7A}" dt="2022-02-14T17:55:05.317" v="175" actId="47"/>
        <pc:sldMkLst>
          <pc:docMk/>
          <pc:sldMk cId="2796464803" sldId="270"/>
        </pc:sldMkLst>
        <pc:graphicFrameChg chg="add mod">
          <ac:chgData name="Mark Ihrie" userId="b056c03dfdfb59ce" providerId="LiveId" clId="{FF7038B4-4E4C-4B4B-BD81-4D765AB1CB7A}" dt="2022-02-14T17:54:43.253" v="169"/>
          <ac:graphicFrameMkLst>
            <pc:docMk/>
            <pc:sldMk cId="2796464803" sldId="270"/>
            <ac:graphicFrameMk id="2" creationId="{586E17E5-A9F3-430F-A904-51985D4596B5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30A7D8-5C2B-44ED-AF58-4503FAABC174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88E70E-1D72-4A66-B372-8E4D2DF43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807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hematic of mouse dosing protocol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7C2C55A-0038-47C1-941A-37800E6F264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9465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ditional ELISA data. Mouse leptin levels measured in serum, presented as A) mixed-sex groupings and B) by-sex groupings n=12-17 mice per group for mixed-sex groups, n=6-9 mice per group per sex. ^^p&lt;0.01 vs. male by three-way ANOVA with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Šidák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rrection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7C2C55A-0038-47C1-941A-37800E6F264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9587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ditional lung physiology measurements in mixed-sex groups: A)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wtoni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sistance, B) tissue elastance, and C) elastance. No significant changes were observed, n=11-16 mice per group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7C2C55A-0038-47C1-941A-37800E6F264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4746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503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43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736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417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50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833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975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276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383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766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213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628A48-02F2-402C-8295-4674029CD619}" type="datetimeFigureOut">
              <a:rPr lang="en-US" smtClean="0"/>
              <a:t>4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E1419-2ABB-4E43-8CED-4DA4DDA17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088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8.bin"/><Relationship Id="rId7" Type="http://schemas.openxmlformats.org/officeDocument/2006/relationships/oleObject" Target="../embeddings/oleObject10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6C05E701-58B5-458A-AFC6-8FB57EE92936}"/>
              </a:ext>
            </a:extLst>
          </p:cNvPr>
          <p:cNvGrpSpPr/>
          <p:nvPr/>
        </p:nvGrpSpPr>
        <p:grpSpPr>
          <a:xfrm>
            <a:off x="524933" y="2828182"/>
            <a:ext cx="6722534" cy="2345266"/>
            <a:chOff x="550333" y="1168715"/>
            <a:chExt cx="6722534" cy="2345266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167BB38-DE23-422D-8FEE-AD3D5D30D1EE}"/>
                </a:ext>
              </a:extLst>
            </p:cNvPr>
            <p:cNvSpPr txBox="1"/>
            <p:nvPr/>
          </p:nvSpPr>
          <p:spPr>
            <a:xfrm>
              <a:off x="2851150" y="1492733"/>
              <a:ext cx="20701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l-GR" sz="14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g HDM or PBS 5 times per week (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i.n.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r>
                <a:rPr lang="en-US" sz="1400" dirty="0"/>
                <a:t> 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DDD1918-FB2C-4ED2-B01C-8C91393CE1FF}"/>
                </a:ext>
              </a:extLst>
            </p:cNvPr>
            <p:cNvSpPr txBox="1"/>
            <p:nvPr/>
          </p:nvSpPr>
          <p:spPr>
            <a:xfrm>
              <a:off x="781050" y="1639764"/>
              <a:ext cx="2070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Wildtype (C57BL/6J)</a:t>
              </a:r>
              <a:endParaRPr lang="en-US" sz="14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A726A74-EE55-4657-9E18-47A6A76C5DC0}"/>
                </a:ext>
              </a:extLst>
            </p:cNvPr>
            <p:cNvSpPr txBox="1"/>
            <p:nvPr/>
          </p:nvSpPr>
          <p:spPr>
            <a:xfrm>
              <a:off x="4921250" y="1485913"/>
              <a:ext cx="20701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ung mechanics / BAL and tissue collection</a:t>
              </a:r>
              <a:endParaRPr lang="en-US" sz="14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751B767-6406-44E5-A5DD-8B3DD2E41A30}"/>
                </a:ext>
              </a:extLst>
            </p:cNvPr>
            <p:cNvSpPr txBox="1"/>
            <p:nvPr/>
          </p:nvSpPr>
          <p:spPr>
            <a:xfrm>
              <a:off x="2851150" y="2104840"/>
              <a:ext cx="2070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6 weeks</a:t>
              </a:r>
              <a:endParaRPr lang="en-US" sz="1400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91BDD27-17CA-4FE4-8AB5-C5BE829DA8B4}"/>
                </a:ext>
              </a:extLst>
            </p:cNvPr>
            <p:cNvSpPr txBox="1"/>
            <p:nvPr/>
          </p:nvSpPr>
          <p:spPr>
            <a:xfrm>
              <a:off x="2633527" y="2683647"/>
              <a:ext cx="255614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 mg/ml leptin or saline control 5 times per week (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.c.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4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C766D3B-2B2A-45CB-B570-F0E78E9254FC}"/>
                </a:ext>
              </a:extLst>
            </p:cNvPr>
            <p:cNvSpPr txBox="1"/>
            <p:nvPr/>
          </p:nvSpPr>
          <p:spPr>
            <a:xfrm>
              <a:off x="1444595" y="2236612"/>
              <a:ext cx="5355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ay</a:t>
              </a:r>
              <a:endParaRPr lang="en-US" sz="1400" dirty="0"/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BE9DB7C0-A77E-42E7-84EA-1E5E5DE3E48A}"/>
                </a:ext>
              </a:extLst>
            </p:cNvPr>
            <p:cNvCxnSpPr>
              <a:cxnSpLocks/>
            </p:cNvCxnSpPr>
            <p:nvPr/>
          </p:nvCxnSpPr>
          <p:spPr>
            <a:xfrm>
              <a:off x="550333" y="2098019"/>
              <a:ext cx="672253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35D9A387-16EA-46F4-B00F-F8FEDA41B775}"/>
                </a:ext>
              </a:extLst>
            </p:cNvPr>
            <p:cNvSpPr/>
            <p:nvPr/>
          </p:nvSpPr>
          <p:spPr>
            <a:xfrm>
              <a:off x="550333" y="1168715"/>
              <a:ext cx="6722534" cy="234526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165BC897-6F61-4051-A45E-A8725EA6506B}"/>
                </a:ext>
              </a:extLst>
            </p:cNvPr>
            <p:cNvCxnSpPr/>
            <p:nvPr/>
          </p:nvCxnSpPr>
          <p:spPr>
            <a:xfrm>
              <a:off x="2726266" y="2412617"/>
              <a:ext cx="237066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26FE000-E36F-43D7-92DE-F00CEACBF5E7}"/>
                </a:ext>
              </a:extLst>
            </p:cNvPr>
            <p:cNvSpPr txBox="1"/>
            <p:nvPr/>
          </p:nvSpPr>
          <p:spPr>
            <a:xfrm>
              <a:off x="2127228" y="2236613"/>
              <a:ext cx="3090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4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94D88A4-DAB5-4E56-B540-B5CAD3BB0B95}"/>
                </a:ext>
              </a:extLst>
            </p:cNvPr>
            <p:cNvSpPr txBox="1"/>
            <p:nvPr/>
          </p:nvSpPr>
          <p:spPr>
            <a:xfrm>
              <a:off x="5676884" y="2258728"/>
              <a:ext cx="4201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n-US" sz="1400" dirty="0"/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F715B280-C260-4ACE-ACB3-FAE9ED021892}"/>
                </a:ext>
              </a:extLst>
            </p:cNvPr>
            <p:cNvCxnSpPr>
              <a:endCxn id="20" idx="0"/>
            </p:cNvCxnSpPr>
            <p:nvPr/>
          </p:nvCxnSpPr>
          <p:spPr>
            <a:xfrm>
              <a:off x="2281752" y="1990298"/>
              <a:ext cx="0" cy="24631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A233EC81-B82C-429C-83E0-47A3EF1124FF}"/>
                </a:ext>
              </a:extLst>
            </p:cNvPr>
            <p:cNvCxnSpPr/>
            <p:nvPr/>
          </p:nvCxnSpPr>
          <p:spPr>
            <a:xfrm>
              <a:off x="5891190" y="1954717"/>
              <a:ext cx="0" cy="24631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3AA077E1-F95B-4525-9E25-E0C07EA153E8}"/>
                </a:ext>
              </a:extLst>
            </p:cNvPr>
            <p:cNvCxnSpPr/>
            <p:nvPr/>
          </p:nvCxnSpPr>
          <p:spPr>
            <a:xfrm flipV="1">
              <a:off x="3886200" y="2447114"/>
              <a:ext cx="0" cy="26161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2E2A0478-00F8-45BC-8753-E336A73317F0}"/>
              </a:ext>
            </a:extLst>
          </p:cNvPr>
          <p:cNvSpPr txBox="1"/>
          <p:nvPr/>
        </p:nvSpPr>
        <p:spPr>
          <a:xfrm>
            <a:off x="508514" y="5597953"/>
            <a:ext cx="5142970" cy="5669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hematic of mouse dosing protocol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64988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1">
            <a:extLst>
              <a:ext uri="{FF2B5EF4-FFF2-40B4-BE49-F238E27FC236}">
                <a16:creationId xmlns:a16="http://schemas.microsoft.com/office/drawing/2014/main" id="{89E6C66C-68AD-4414-90F3-DB4FC38BAF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9483680"/>
              </p:ext>
            </p:extLst>
          </p:nvPr>
        </p:nvGraphicFramePr>
        <p:xfrm>
          <a:off x="3529666" y="3091749"/>
          <a:ext cx="3946525" cy="2449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946539" imgH="2448819" progId="Prism9.Document">
                  <p:embed/>
                </p:oleObj>
              </mc:Choice>
              <mc:Fallback>
                <p:oleObj name="Prism 9" r:id="rId3" imgW="3946539" imgH="2448819" progId="Prism9.Document">
                  <p:embed/>
                  <p:pic>
                    <p:nvPicPr>
                      <p:cNvPr id="5" name="Object 1">
                        <a:extLst>
                          <a:ext uri="{FF2B5EF4-FFF2-40B4-BE49-F238E27FC236}">
                            <a16:creationId xmlns:a16="http://schemas.microsoft.com/office/drawing/2014/main" id="{89E6C66C-68AD-4414-90F3-DB4FC38BAF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29666" y="3091749"/>
                        <a:ext cx="3946525" cy="2449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1">
            <a:extLst>
              <a:ext uri="{FF2B5EF4-FFF2-40B4-BE49-F238E27FC236}">
                <a16:creationId xmlns:a16="http://schemas.microsoft.com/office/drawing/2014/main" id="{3FA321A7-8610-4372-A1E6-6C591B6266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2110962"/>
              </p:ext>
            </p:extLst>
          </p:nvPr>
        </p:nvGraphicFramePr>
        <p:xfrm>
          <a:off x="497541" y="2977448"/>
          <a:ext cx="3032125" cy="267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032255" imgH="2678834" progId="Prism9.Document">
                  <p:embed/>
                </p:oleObj>
              </mc:Choice>
              <mc:Fallback>
                <p:oleObj name="Prism 9" r:id="rId5" imgW="3032255" imgH="2678834" progId="Prism9.Document">
                  <p:embed/>
                  <p:pic>
                    <p:nvPicPr>
                      <p:cNvPr id="6" name="Object 1">
                        <a:extLst>
                          <a:ext uri="{FF2B5EF4-FFF2-40B4-BE49-F238E27FC236}">
                            <a16:creationId xmlns:a16="http://schemas.microsoft.com/office/drawing/2014/main" id="{3FA321A7-8610-4372-A1E6-6C591B6266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7541" y="2977448"/>
                        <a:ext cx="3032125" cy="2678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10">
            <a:extLst>
              <a:ext uri="{FF2B5EF4-FFF2-40B4-BE49-F238E27FC236}">
                <a16:creationId xmlns:a16="http://schemas.microsoft.com/office/drawing/2014/main" id="{ECF1F17A-7FCD-4A64-BE69-746292696253}"/>
              </a:ext>
            </a:extLst>
          </p:cNvPr>
          <p:cNvSpPr txBox="1"/>
          <p:nvPr/>
        </p:nvSpPr>
        <p:spPr>
          <a:xfrm>
            <a:off x="549705" y="2722417"/>
            <a:ext cx="41370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C7F19CAC-BF79-40FD-8600-64E01718505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74545" y="3258158"/>
            <a:ext cx="1170626" cy="94169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E2A6C2B-5466-4154-AAC3-FED68517CD2E}"/>
              </a:ext>
            </a:extLst>
          </p:cNvPr>
          <p:cNvSpPr txBox="1"/>
          <p:nvPr/>
        </p:nvSpPr>
        <p:spPr>
          <a:xfrm>
            <a:off x="3926541" y="2722417"/>
            <a:ext cx="41370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09AF426-25D5-4F1B-9DA1-3CDE1A6E32DB}"/>
              </a:ext>
            </a:extLst>
          </p:cNvPr>
          <p:cNvSpPr txBox="1"/>
          <p:nvPr/>
        </p:nvSpPr>
        <p:spPr>
          <a:xfrm>
            <a:off x="497541" y="5910592"/>
            <a:ext cx="675452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dditional ELISA data. Mouse leptin levels measured in serum, presented as A) mixed-sex groupings and B) by-sex groupings n=12-17 mice per group for mixed-sex groups, n=6-9 mice per group per sex. ^^p&lt;0.01 vs. male by three-way ANOVA with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Šidák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rrection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61131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F36E899-8FEA-4D02-AB5D-800DADADFD8C}"/>
              </a:ext>
            </a:extLst>
          </p:cNvPr>
          <p:cNvSpPr txBox="1"/>
          <p:nvPr/>
        </p:nvSpPr>
        <p:spPr>
          <a:xfrm>
            <a:off x="497541" y="5910592"/>
            <a:ext cx="675452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hange from week 0 to week 6 of the area under the glucose tolerance curves. No significant differences were observed between treatment group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72D3346-31DD-462B-9187-CC81B1FCD7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4528079"/>
              </p:ext>
            </p:extLst>
          </p:nvPr>
        </p:nvGraphicFramePr>
        <p:xfrm>
          <a:off x="2299208" y="2937062"/>
          <a:ext cx="3151187" cy="2705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151400" imgH="2704752" progId="Prism9.Document">
                  <p:embed/>
                </p:oleObj>
              </mc:Choice>
              <mc:Fallback>
                <p:oleObj name="Prism 9" r:id="rId2" imgW="3151400" imgH="2704752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72D3346-31DD-462B-9187-CC81B1FCD7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99208" y="2937062"/>
                        <a:ext cx="3151187" cy="2705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614932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CCDAA3D-2257-4795-93DB-A1B906D5ECAD}"/>
              </a:ext>
            </a:extLst>
          </p:cNvPr>
          <p:cNvSpPr txBox="1"/>
          <p:nvPr/>
        </p:nvSpPr>
        <p:spPr>
          <a:xfrm>
            <a:off x="508939" y="7060982"/>
            <a:ext cx="675452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dditional qPCR and ELISA data from whole lung; and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broblast invasion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MUC5AC was significantly increased (*p&lt;0.05) by HDM exposure. No significant changes in were seen in </a:t>
            </a:r>
            <a:r>
              <a:rPr lang="en-US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ln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c5b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RNA expression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A52B1F09-9508-4B85-A5FF-4BFEC11A6F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792542"/>
              </p:ext>
            </p:extLst>
          </p:nvPr>
        </p:nvGraphicFramePr>
        <p:xfrm>
          <a:off x="3886200" y="735161"/>
          <a:ext cx="3062287" cy="2681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062851" imgH="2682074" progId="Prism9.Document">
                  <p:embed/>
                </p:oleObj>
              </mc:Choice>
              <mc:Fallback>
                <p:oleObj name="Prism 9" r:id="rId2" imgW="3062851" imgH="2682074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A52B1F09-9508-4B85-A5FF-4BFEC11A6F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86200" y="735161"/>
                        <a:ext cx="3062287" cy="2681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E74C0B4-A6CF-468B-BB2E-9420847BAE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5224786"/>
              </p:ext>
            </p:extLst>
          </p:nvPr>
        </p:nvGraphicFramePr>
        <p:xfrm>
          <a:off x="1163096" y="3745802"/>
          <a:ext cx="2876550" cy="267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877115" imgH="2678834" progId="Prism9.Document">
                  <p:embed/>
                </p:oleObj>
              </mc:Choice>
              <mc:Fallback>
                <p:oleObj name="Prism 9" r:id="rId4" imgW="2877115" imgH="2678834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E74C0B4-A6CF-468B-BB2E-9420847BAE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63096" y="3745802"/>
                        <a:ext cx="2876550" cy="2678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10">
            <a:extLst>
              <a:ext uri="{FF2B5EF4-FFF2-40B4-BE49-F238E27FC236}">
                <a16:creationId xmlns:a16="http://schemas.microsoft.com/office/drawing/2014/main" id="{63F29EF2-1711-41A0-ADAA-E9D146E60190}"/>
              </a:ext>
            </a:extLst>
          </p:cNvPr>
          <p:cNvSpPr txBox="1"/>
          <p:nvPr/>
        </p:nvSpPr>
        <p:spPr>
          <a:xfrm>
            <a:off x="738014" y="735161"/>
            <a:ext cx="41370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4B696B7-BDB2-4134-8352-F774CD1548A2}"/>
              </a:ext>
            </a:extLst>
          </p:cNvPr>
          <p:cNvSpPr txBox="1"/>
          <p:nvPr/>
        </p:nvSpPr>
        <p:spPr>
          <a:xfrm>
            <a:off x="3679349" y="735161"/>
            <a:ext cx="41370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419868E-19D5-4971-9EA0-CF4689223B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8261436"/>
              </p:ext>
            </p:extLst>
          </p:nvPr>
        </p:nvGraphicFramePr>
        <p:xfrm>
          <a:off x="956245" y="735161"/>
          <a:ext cx="3052763" cy="2701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052052" imgH="2701872" progId="Prism9.Document">
                  <p:embed/>
                </p:oleObj>
              </mc:Choice>
              <mc:Fallback>
                <p:oleObj name="Prism 9" r:id="rId6" imgW="3052052" imgH="2701872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5419868E-19D5-4971-9EA0-CF4689223B6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56245" y="735161"/>
                        <a:ext cx="3052763" cy="2701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10">
            <a:extLst>
              <a:ext uri="{FF2B5EF4-FFF2-40B4-BE49-F238E27FC236}">
                <a16:creationId xmlns:a16="http://schemas.microsoft.com/office/drawing/2014/main" id="{6841DE14-148A-4195-9A6D-73E7870A1BBA}"/>
              </a:ext>
            </a:extLst>
          </p:cNvPr>
          <p:cNvSpPr txBox="1"/>
          <p:nvPr/>
        </p:nvSpPr>
        <p:spPr>
          <a:xfrm>
            <a:off x="738013" y="3898071"/>
            <a:ext cx="41370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F5DA7371-9340-4466-A0DB-F0A7E30F69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5235572"/>
              </p:ext>
            </p:extLst>
          </p:nvPr>
        </p:nvGraphicFramePr>
        <p:xfrm>
          <a:off x="4009008" y="3693318"/>
          <a:ext cx="2955925" cy="2671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956305" imgH="2671275" progId="Prism9.Document">
                  <p:embed/>
                </p:oleObj>
              </mc:Choice>
              <mc:Fallback>
                <p:oleObj name="Prism 9" r:id="rId8" imgW="2956305" imgH="2671275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F5DA7371-9340-4466-A0DB-F0A7E30F69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009008" y="3693318"/>
                        <a:ext cx="2955925" cy="2671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10">
            <a:extLst>
              <a:ext uri="{FF2B5EF4-FFF2-40B4-BE49-F238E27FC236}">
                <a16:creationId xmlns:a16="http://schemas.microsoft.com/office/drawing/2014/main" id="{9E09D1D1-ECE8-4FF9-86B4-D7634DF9050D}"/>
              </a:ext>
            </a:extLst>
          </p:cNvPr>
          <p:cNvSpPr txBox="1"/>
          <p:nvPr/>
        </p:nvSpPr>
        <p:spPr>
          <a:xfrm>
            <a:off x="3755090" y="3868849"/>
            <a:ext cx="41370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24964329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16D4D6D8-CD25-4179-B2E3-2769329F8E3F}"/>
              </a:ext>
            </a:extLst>
          </p:cNvPr>
          <p:cNvSpPr txBox="1"/>
          <p:nvPr/>
        </p:nvSpPr>
        <p:spPr>
          <a:xfrm>
            <a:off x="476786" y="1221781"/>
            <a:ext cx="41370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B4DDDBB-3B2A-43E3-BD14-E2EB65267593}"/>
              </a:ext>
            </a:extLst>
          </p:cNvPr>
          <p:cNvSpPr txBox="1"/>
          <p:nvPr/>
        </p:nvSpPr>
        <p:spPr>
          <a:xfrm>
            <a:off x="3945948" y="1221781"/>
            <a:ext cx="41370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8FBDC9C-E78A-416F-BA70-8D2B159A8203}"/>
              </a:ext>
            </a:extLst>
          </p:cNvPr>
          <p:cNvSpPr txBox="1"/>
          <p:nvPr/>
        </p:nvSpPr>
        <p:spPr>
          <a:xfrm>
            <a:off x="490267" y="4330045"/>
            <a:ext cx="413701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4D3565F-328F-4149-B5E3-B55FACFD657C}"/>
              </a:ext>
            </a:extLst>
          </p:cNvPr>
          <p:cNvSpPr txBox="1"/>
          <p:nvPr/>
        </p:nvSpPr>
        <p:spPr>
          <a:xfrm>
            <a:off x="522422" y="7353377"/>
            <a:ext cx="675452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lung physiology measurements in mixed-sex groups: A) 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wtonian resistance, B) tissue elastance, and C) elastance. No significant changes were observed, n=11-16 mice per group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1DB29E8D-D3A9-429A-87E9-3ED7892F35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6170462"/>
              </p:ext>
            </p:extLst>
          </p:nvPr>
        </p:nvGraphicFramePr>
        <p:xfrm>
          <a:off x="476786" y="1445211"/>
          <a:ext cx="3422897" cy="2422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829194" imgH="2709431" progId="Prism9.Document">
                  <p:embed/>
                </p:oleObj>
              </mc:Choice>
              <mc:Fallback>
                <p:oleObj name="Prism 9" r:id="rId3" imgW="3829194" imgH="2709431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1DB29E8D-D3A9-429A-87E9-3ED7892F35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6786" y="1445211"/>
                        <a:ext cx="3422897" cy="2422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24CE5573-1A71-44B6-82F0-51EC338599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5124842"/>
              </p:ext>
            </p:extLst>
          </p:nvPr>
        </p:nvGraphicFramePr>
        <p:xfrm>
          <a:off x="4070004" y="1406447"/>
          <a:ext cx="3345106" cy="24177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791398" imgH="2740028" progId="Prism9.Document">
                  <p:embed/>
                </p:oleObj>
              </mc:Choice>
              <mc:Fallback>
                <p:oleObj name="Prism 9" r:id="rId5" imgW="3791398" imgH="2740028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24CE5573-1A71-44B6-82F0-51EC338599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70004" y="1406447"/>
                        <a:ext cx="3345106" cy="24177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1EA88D24-D65A-44D2-8A26-99D28F1C4B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9753398"/>
              </p:ext>
            </p:extLst>
          </p:nvPr>
        </p:nvGraphicFramePr>
        <p:xfrm>
          <a:off x="471597" y="4699377"/>
          <a:ext cx="3395931" cy="24224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798958" imgH="2709431" progId="Prism9.Document">
                  <p:embed/>
                </p:oleObj>
              </mc:Choice>
              <mc:Fallback>
                <p:oleObj name="Prism 9" r:id="rId7" imgW="3798958" imgH="2709431" progId="Prism9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1EA88D24-D65A-44D2-8A26-99D28F1C4B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71597" y="4699377"/>
                        <a:ext cx="3395931" cy="24224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13115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</TotalTime>
  <Words>353</Words>
  <Application>Microsoft Office PowerPoint</Application>
  <PresentationFormat>Custom</PresentationFormat>
  <Paragraphs>28</Paragraphs>
  <Slides>5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9</vt:lpstr>
      <vt:lpstr>GraphPad Prism 9 Projec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Ihrie</dc:creator>
  <cp:lastModifiedBy>Mark Ihrie</cp:lastModifiedBy>
  <cp:revision>1</cp:revision>
  <dcterms:created xsi:type="dcterms:W3CDTF">2021-12-02T17:25:41Z</dcterms:created>
  <dcterms:modified xsi:type="dcterms:W3CDTF">2022-04-22T18:49:49Z</dcterms:modified>
</cp:coreProperties>
</file>